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6420"/>
    <p:restoredTop sz="95865"/>
  </p:normalViewPr>
  <p:slideViewPr>
    <p:cSldViewPr snapToGrid="0">
      <p:cViewPr varScale="1">
        <p:scale>
          <a:sx n="40" d="100"/>
          <a:sy n="40" d="100"/>
        </p:scale>
        <p:origin x="208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C2061-3787-2A67-AF08-F8989F23AF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56BB86-E6F2-8631-CB31-9D3AC825A5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26E01E-A339-AAC4-30AA-F3CCF5662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B1682F-2D87-697D-91A6-0F6F4ED59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0E0C2-AC07-F3FC-00A6-6E21CF1AE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820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29C18-8D0E-25B4-D467-4365D4D01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1B4FA1-E927-2358-31B2-0B4B09EB6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9E189C-BC9D-6EC7-709A-BA8FC979F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159BEE-1DE2-B468-AF4D-A80D4BA46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EC96C-E755-2325-FA55-A5D97FE65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546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D61F58-4D37-55F9-4FBB-88DB10C7AB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63B6A1-A155-F9A7-1C2F-AA37515C5C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9BC32-5584-7536-E575-3EB0FDC78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0A4EC9-A14A-DCF9-5C76-8CC953E4F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B4E08-5751-B182-CD4C-D965FD644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27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3C3BC8-15B8-DF20-E4C6-41370A3535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55A304-9E1B-8D47-4320-07AA62BE92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174EE-5244-144C-857B-58BF12CF4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2DC62-9E77-A8A7-7B4F-3B2FCFBE2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FC3F0-9BC7-B009-1B5F-47A0DEB94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115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38750-CB3F-B9BB-E224-1B3BC936B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F2642F-6D56-F69B-67F2-7A62F8B01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E35D0-A9CB-17B7-5BF1-A73BCD7E1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78B8D-F372-1800-10A5-ABD84F58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EA0774-BAFB-7C59-B1FA-B6F45DB29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633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500BF2-82C9-E453-15D5-9112AF53A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D6523E-F1CC-4828-EAA5-23D9ED1888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930147-97F2-55F6-F90F-09F2128536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51D4E3-B1BD-8CD4-EF58-70AEA0BE1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E7BE4B-B1C7-6804-02BE-E9B308693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7DA0DE-DE22-5A12-5B82-9918BC9E8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820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A8A6F-60D7-B8DC-5B46-86DA99D742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2A9AA9-7EBC-3F57-F1C3-C6DFC42BDC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AB843D-A242-DE42-3536-C8E677AADC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48F767-AE1D-9CA8-7AFC-7B6A5B033C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68F28DF-A1C3-DEE6-11E5-A924EB7063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A8A5C5-338C-5F35-1E3E-900E21A79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8EF3A1-4E94-A23B-88FF-177A85E9D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E10BEE-8BE3-2B06-6A8D-85A25DB08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105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C2F61-89D1-E2E6-2FAB-AD08EDF7D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90DC7B-E886-C1F5-41BF-1C52D5240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8CE3EC-7F84-7719-F927-5D5E7EED5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C942FF-BAB9-BB2D-D85E-32713E326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458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FB5DF3-5375-81EE-06BD-4B158369A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0DBC04-485F-C619-686E-C0F08C1EA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E8BDD6-F01E-3E03-F921-0D625A8CF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672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10618-B6BB-B055-BB98-821D8C79C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325C9F-F339-3671-9AA9-3738FB79B0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73878E-E295-BE35-2DA5-76F3D8E9A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86283E-494B-6F9A-853D-7C337E204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BF07C7-5BBB-1D68-660F-E3547720A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4E3E4C-B09B-6473-1839-3606C1723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935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0948F-0110-3550-BE87-B673A818B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ADD2E3-1AFB-4C0B-162F-ED225516B4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19082-4452-A0C6-BDE7-8DB360BF8C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53FD82-692A-13E5-D23C-287164221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F1C3AD-26F6-FF76-F3D4-86A7C3AA9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F7D5B1-281F-89F5-54B0-CAC2CAB27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298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CDC306-636E-6249-17B3-20A1A3383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CBCF31-F879-594D-3E2F-1FE027863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1457D-7152-1B67-9365-F882BDB5E9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98D07C-AB60-BC41-B2DF-744266C2B116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D15E80-A9FC-055F-4FFA-D784ECA143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6E9F7F-CDFD-E222-A8F8-F64D73F2E1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1DA24-FD0F-F949-BEF0-3AE73FF02C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995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EABB34E6-F82B-9C1F-0F02-B6A6318621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8"/>
          <a:stretch/>
        </p:blipFill>
        <p:spPr>
          <a:xfrm>
            <a:off x="6096000" y="1578146"/>
            <a:ext cx="5865568" cy="4178882"/>
          </a:xfrm>
          <a:prstGeom prst="rect">
            <a:avLst/>
          </a:prstGeom>
        </p:spPr>
      </p:pic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E6A0FAE3-0B8D-A244-FFE2-1D94FBD72D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8"/>
          <a:stretch/>
        </p:blipFill>
        <p:spPr>
          <a:xfrm>
            <a:off x="230432" y="1578146"/>
            <a:ext cx="5865568" cy="41788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5252456-2110-963A-29EB-C48773516C52}"/>
              </a:ext>
            </a:extLst>
          </p:cNvPr>
          <p:cNvSpPr txBox="1"/>
          <p:nvPr/>
        </p:nvSpPr>
        <p:spPr>
          <a:xfrm>
            <a:off x="6096000" y="1578144"/>
            <a:ext cx="528839" cy="3776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5B2549-C01B-8AA6-13DB-DCFF450C97ED}"/>
              </a:ext>
            </a:extLst>
          </p:cNvPr>
          <p:cNvSpPr txBox="1"/>
          <p:nvPr/>
        </p:nvSpPr>
        <p:spPr>
          <a:xfrm>
            <a:off x="230432" y="1578144"/>
            <a:ext cx="528839" cy="3776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8B352ED-FFC2-3E4F-95C9-E2585D7E1807}"/>
              </a:ext>
            </a:extLst>
          </p:cNvPr>
          <p:cNvSpPr txBox="1"/>
          <p:nvPr/>
        </p:nvSpPr>
        <p:spPr>
          <a:xfrm>
            <a:off x="494851" y="146865"/>
            <a:ext cx="610688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1: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Kaplan-Meier analysis in response evaluable patients for A) PFS and B) OS stratified by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PIK3C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mutation.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8404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Scott</dc:creator>
  <cp:lastModifiedBy>Aaron Scott</cp:lastModifiedBy>
  <cp:revision>2</cp:revision>
  <dcterms:created xsi:type="dcterms:W3CDTF">2022-07-21T20:32:04Z</dcterms:created>
  <dcterms:modified xsi:type="dcterms:W3CDTF">2022-07-21T20:33:54Z</dcterms:modified>
</cp:coreProperties>
</file>